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95" d="100"/>
          <a:sy n="95" d="100"/>
        </p:scale>
        <p:origin x="67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LWANG_Cdrive\MS%20fish%20Cmap\DEG%20summar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LWANG_Cdrive\MS%20fish%20Cmap\DEG%20summary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RLWANG_Cdrive\MS%20fish%20Cmap\DEG%20summary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veLogFC</a:t>
            </a:r>
            <a:r>
              <a:rPr lang="en-US" baseline="0"/>
              <a:t> vs Norm_Score</a:t>
            </a:r>
            <a:endParaRPr 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6!$L$6</c:f>
              <c:strCache>
                <c:ptCount val="1"/>
                <c:pt idx="0">
                  <c:v>AveLogFC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/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Sheet6!$J$7:$J$112</c:f>
              <c:numCache>
                <c:formatCode>General</c:formatCode>
                <c:ptCount val="106"/>
                <c:pt idx="0">
                  <c:v>0.25809880331956303</c:v>
                </c:pt>
                <c:pt idx="1">
                  <c:v>0.21527219352437801</c:v>
                </c:pt>
                <c:pt idx="2">
                  <c:v>0.20361338260515299</c:v>
                </c:pt>
                <c:pt idx="3">
                  <c:v>0.226874222316271</c:v>
                </c:pt>
                <c:pt idx="4">
                  <c:v>0.19919340650262898</c:v>
                </c:pt>
                <c:pt idx="5">
                  <c:v>0.21733990743135098</c:v>
                </c:pt>
                <c:pt idx="6">
                  <c:v>0.18768047845210797</c:v>
                </c:pt>
                <c:pt idx="7">
                  <c:v>0.18768047845210797</c:v>
                </c:pt>
                <c:pt idx="8">
                  <c:v>0.15162826462138501</c:v>
                </c:pt>
                <c:pt idx="9">
                  <c:v>0.226874222316271</c:v>
                </c:pt>
                <c:pt idx="10">
                  <c:v>0.180582215521153</c:v>
                </c:pt>
                <c:pt idx="11">
                  <c:v>0.17580128234332901</c:v>
                </c:pt>
                <c:pt idx="12">
                  <c:v>0.17580128234332901</c:v>
                </c:pt>
                <c:pt idx="13">
                  <c:v>0.13607179660629198</c:v>
                </c:pt>
                <c:pt idx="14">
                  <c:v>0.19099553663033098</c:v>
                </c:pt>
                <c:pt idx="15">
                  <c:v>0.22603837781772601</c:v>
                </c:pt>
                <c:pt idx="16">
                  <c:v>0.27011711960738599</c:v>
                </c:pt>
                <c:pt idx="17">
                  <c:v>0.17965215232127099</c:v>
                </c:pt>
                <c:pt idx="18">
                  <c:v>0.16410191475552799</c:v>
                </c:pt>
                <c:pt idx="19">
                  <c:v>0.20265788992316602</c:v>
                </c:pt>
                <c:pt idx="20">
                  <c:v>0.20265788992316602</c:v>
                </c:pt>
                <c:pt idx="21">
                  <c:v>0.14035954121904001</c:v>
                </c:pt>
                <c:pt idx="22">
                  <c:v>0.226874222316271</c:v>
                </c:pt>
                <c:pt idx="23">
                  <c:v>0.258523199886879</c:v>
                </c:pt>
                <c:pt idx="24">
                  <c:v>0.14035954121904001</c:v>
                </c:pt>
                <c:pt idx="25">
                  <c:v>0.22406903532082001</c:v>
                </c:pt>
                <c:pt idx="26">
                  <c:v>0.10043112464825199</c:v>
                </c:pt>
                <c:pt idx="27">
                  <c:v>0.17965215232127099</c:v>
                </c:pt>
                <c:pt idx="28">
                  <c:v>0.22915370222847201</c:v>
                </c:pt>
                <c:pt idx="29">
                  <c:v>0.216681656690528</c:v>
                </c:pt>
                <c:pt idx="30">
                  <c:v>0.12470518805955899</c:v>
                </c:pt>
                <c:pt idx="31">
                  <c:v>0.18672997442841102</c:v>
                </c:pt>
                <c:pt idx="32">
                  <c:v>0.18672997442841102</c:v>
                </c:pt>
                <c:pt idx="33">
                  <c:v>0.16464099402941598</c:v>
                </c:pt>
                <c:pt idx="34">
                  <c:v>0.21938241223496199</c:v>
                </c:pt>
                <c:pt idx="35">
                  <c:v>0.226874222316271</c:v>
                </c:pt>
                <c:pt idx="36">
                  <c:v>0.14244011914087099</c:v>
                </c:pt>
                <c:pt idx="37">
                  <c:v>0.22112752801215099</c:v>
                </c:pt>
                <c:pt idx="38">
                  <c:v>0.28433715181837999</c:v>
                </c:pt>
                <c:pt idx="39">
                  <c:v>0.202539616111309</c:v>
                </c:pt>
                <c:pt idx="40">
                  <c:v>0.175044815738296</c:v>
                </c:pt>
                <c:pt idx="41">
                  <c:v>0.15721356914988902</c:v>
                </c:pt>
                <c:pt idx="42">
                  <c:v>0.23584496572861099</c:v>
                </c:pt>
                <c:pt idx="43">
                  <c:v>0.21733990743135098</c:v>
                </c:pt>
                <c:pt idx="44">
                  <c:v>0.22089464014316601</c:v>
                </c:pt>
                <c:pt idx="45">
                  <c:v>0.21938241223496199</c:v>
                </c:pt>
                <c:pt idx="46">
                  <c:v>0.228732134381464</c:v>
                </c:pt>
                <c:pt idx="47">
                  <c:v>0.14365630214927599</c:v>
                </c:pt>
                <c:pt idx="48">
                  <c:v>0.26138941480163802</c:v>
                </c:pt>
                <c:pt idx="49">
                  <c:v>0.13961939955534999</c:v>
                </c:pt>
                <c:pt idx="50">
                  <c:v>0.24007901432283202</c:v>
                </c:pt>
                <c:pt idx="51">
                  <c:v>0.24320865833586999</c:v>
                </c:pt>
                <c:pt idx="52">
                  <c:v>0.22315800903046998</c:v>
                </c:pt>
                <c:pt idx="53">
                  <c:v>0.23861874939821601</c:v>
                </c:pt>
                <c:pt idx="54">
                  <c:v>0.187908242768248</c:v>
                </c:pt>
                <c:pt idx="55">
                  <c:v>0.23374248316931698</c:v>
                </c:pt>
                <c:pt idx="56">
                  <c:v>0.21768477138918901</c:v>
                </c:pt>
                <c:pt idx="57">
                  <c:v>0.24349572626935401</c:v>
                </c:pt>
                <c:pt idx="58">
                  <c:v>0.20361338260515299</c:v>
                </c:pt>
                <c:pt idx="59">
                  <c:v>0.28123910104205802</c:v>
                </c:pt>
                <c:pt idx="60">
                  <c:v>0.20989276830490097</c:v>
                </c:pt>
                <c:pt idx="61">
                  <c:v>0.216937376976754</c:v>
                </c:pt>
                <c:pt idx="62">
                  <c:v>0.21318933818452501</c:v>
                </c:pt>
                <c:pt idx="63">
                  <c:v>0.246451173169878</c:v>
                </c:pt>
                <c:pt idx="64">
                  <c:v>0.21041441821283999</c:v>
                </c:pt>
                <c:pt idx="65">
                  <c:v>0.18768047845210797</c:v>
                </c:pt>
                <c:pt idx="66">
                  <c:v>0.18768047845210797</c:v>
                </c:pt>
                <c:pt idx="67">
                  <c:v>0.20755594506170003</c:v>
                </c:pt>
                <c:pt idx="68">
                  <c:v>0.25979671045103331</c:v>
                </c:pt>
                <c:pt idx="69">
                  <c:v>0.18672997442841102</c:v>
                </c:pt>
                <c:pt idx="70">
                  <c:v>0.18672997442841102</c:v>
                </c:pt>
                <c:pt idx="71">
                  <c:v>0.20620837516747417</c:v>
                </c:pt>
                <c:pt idx="72">
                  <c:v>0.2304572623676989</c:v>
                </c:pt>
                <c:pt idx="73">
                  <c:v>0.20265788992316602</c:v>
                </c:pt>
                <c:pt idx="74">
                  <c:v>0.20265788992316602</c:v>
                </c:pt>
                <c:pt idx="75">
                  <c:v>0.13579875598259644</c:v>
                </c:pt>
                <c:pt idx="76">
                  <c:v>0.22297230758653133</c:v>
                </c:pt>
                <c:pt idx="77">
                  <c:v>0.28520508087827728</c:v>
                </c:pt>
                <c:pt idx="78">
                  <c:v>0.26236829892012353</c:v>
                </c:pt>
                <c:pt idx="79">
                  <c:v>0.23805695020735296</c:v>
                </c:pt>
                <c:pt idx="80">
                  <c:v>0.11714346191704689</c:v>
                </c:pt>
                <c:pt idx="81">
                  <c:v>0.139064538391657</c:v>
                </c:pt>
                <c:pt idx="82">
                  <c:v>0.21672438106190001</c:v>
                </c:pt>
                <c:pt idx="83">
                  <c:v>0.25930422654546303</c:v>
                </c:pt>
                <c:pt idx="84">
                  <c:v>0.20689123687012001</c:v>
                </c:pt>
                <c:pt idx="85">
                  <c:v>0.13763678478819447</c:v>
                </c:pt>
                <c:pt idx="86">
                  <c:v>0.20689123687012001</c:v>
                </c:pt>
                <c:pt idx="87">
                  <c:v>0.15545866791995369</c:v>
                </c:pt>
                <c:pt idx="88">
                  <c:v>0.3158972678036065</c:v>
                </c:pt>
                <c:pt idx="89">
                  <c:v>0.29953027199120152</c:v>
                </c:pt>
                <c:pt idx="90">
                  <c:v>0.19099399551717638</c:v>
                </c:pt>
                <c:pt idx="91">
                  <c:v>0.22898324279678872</c:v>
                </c:pt>
                <c:pt idx="92">
                  <c:v>0.180582215521153</c:v>
                </c:pt>
                <c:pt idx="93">
                  <c:v>0.15465543963380524</c:v>
                </c:pt>
                <c:pt idx="94">
                  <c:v>0.29557430740719287</c:v>
                </c:pt>
                <c:pt idx="95">
                  <c:v>0.40884190819256</c:v>
                </c:pt>
                <c:pt idx="96">
                  <c:v>0.59600311126668237</c:v>
                </c:pt>
                <c:pt idx="97">
                  <c:v>0.47383898024497045</c:v>
                </c:pt>
                <c:pt idx="98">
                  <c:v>0.18490824399299172</c:v>
                </c:pt>
                <c:pt idx="99">
                  <c:v>0.55941572965099917</c:v>
                </c:pt>
                <c:pt idx="100">
                  <c:v>0.33921432839399501</c:v>
                </c:pt>
                <c:pt idx="101">
                  <c:v>0.6603924291877824</c:v>
                </c:pt>
                <c:pt idx="102">
                  <c:v>0.41034996829800002</c:v>
                </c:pt>
                <c:pt idx="103">
                  <c:v>0.32946859487498997</c:v>
                </c:pt>
                <c:pt idx="104">
                  <c:v>0.85338633063268998</c:v>
                </c:pt>
                <c:pt idx="105">
                  <c:v>0.49968261586550416</c:v>
                </c:pt>
              </c:numCache>
            </c:numRef>
          </c:xVal>
          <c:yVal>
            <c:numRef>
              <c:f>Sheet6!$L$7:$L$112</c:f>
              <c:numCache>
                <c:formatCode>General</c:formatCode>
                <c:ptCount val="106"/>
                <c:pt idx="0">
                  <c:v>0.4916683</c:v>
                </c:pt>
                <c:pt idx="1">
                  <c:v>1.3601939999999999</c:v>
                </c:pt>
                <c:pt idx="2">
                  <c:v>0.62505544999999996</c:v>
                </c:pt>
                <c:pt idx="3">
                  <c:v>0.56833235000000004</c:v>
                </c:pt>
                <c:pt idx="4">
                  <c:v>0.91419260000000002</c:v>
                </c:pt>
                <c:pt idx="5">
                  <c:v>0.61132149999999996</c:v>
                </c:pt>
                <c:pt idx="6">
                  <c:v>0.4008274</c:v>
                </c:pt>
                <c:pt idx="7">
                  <c:v>0.61339860000000002</c:v>
                </c:pt>
                <c:pt idx="8">
                  <c:v>0.51797219999999999</c:v>
                </c:pt>
                <c:pt idx="9">
                  <c:v>0.56833235000000004</c:v>
                </c:pt>
                <c:pt idx="10">
                  <c:v>1.6445524</c:v>
                </c:pt>
                <c:pt idx="11">
                  <c:v>0.40994390000000003</c:v>
                </c:pt>
                <c:pt idx="12">
                  <c:v>0.40994390000000003</c:v>
                </c:pt>
                <c:pt idx="13">
                  <c:v>0.69967780000000002</c:v>
                </c:pt>
                <c:pt idx="14">
                  <c:v>1.192707</c:v>
                </c:pt>
                <c:pt idx="15">
                  <c:v>0.4273825</c:v>
                </c:pt>
                <c:pt idx="16">
                  <c:v>0.4347569</c:v>
                </c:pt>
                <c:pt idx="17">
                  <c:v>0.93560125000000005</c:v>
                </c:pt>
                <c:pt idx="18">
                  <c:v>0.71165730000000005</c:v>
                </c:pt>
                <c:pt idx="19">
                  <c:v>0.46716279999999999</c:v>
                </c:pt>
                <c:pt idx="20">
                  <c:v>0.7814797</c:v>
                </c:pt>
                <c:pt idx="21">
                  <c:v>1.5586838999999999</c:v>
                </c:pt>
                <c:pt idx="22">
                  <c:v>0.56833235000000004</c:v>
                </c:pt>
                <c:pt idx="23">
                  <c:v>0.57281780000000004</c:v>
                </c:pt>
                <c:pt idx="24">
                  <c:v>1.5586838999999999</c:v>
                </c:pt>
                <c:pt idx="25">
                  <c:v>0.85598819999999998</c:v>
                </c:pt>
                <c:pt idx="26">
                  <c:v>1.229508</c:v>
                </c:pt>
                <c:pt idx="27">
                  <c:v>0.93560125000000005</c:v>
                </c:pt>
                <c:pt idx="28">
                  <c:v>1.711883</c:v>
                </c:pt>
                <c:pt idx="29">
                  <c:v>1.0264759999999999</c:v>
                </c:pt>
                <c:pt idx="30">
                  <c:v>0.71161350000000001</c:v>
                </c:pt>
                <c:pt idx="31">
                  <c:v>0.49193409999999999</c:v>
                </c:pt>
                <c:pt idx="32">
                  <c:v>0.83761359999999996</c:v>
                </c:pt>
                <c:pt idx="33">
                  <c:v>0.69904520000000003</c:v>
                </c:pt>
                <c:pt idx="34">
                  <c:v>0.74534520000000004</c:v>
                </c:pt>
                <c:pt idx="35">
                  <c:v>0.56833235000000004</c:v>
                </c:pt>
                <c:pt idx="36">
                  <c:v>0.8486591</c:v>
                </c:pt>
                <c:pt idx="37">
                  <c:v>0.67366510000000002</c:v>
                </c:pt>
                <c:pt idx="38">
                  <c:v>0.48918840000000002</c:v>
                </c:pt>
                <c:pt idx="39">
                  <c:v>1.821731</c:v>
                </c:pt>
                <c:pt idx="40">
                  <c:v>0.51500349999999995</c:v>
                </c:pt>
                <c:pt idx="41">
                  <c:v>0.76376999999999995</c:v>
                </c:pt>
                <c:pt idx="42">
                  <c:v>0.34944439999999999</c:v>
                </c:pt>
                <c:pt idx="43">
                  <c:v>0.61132149999999996</c:v>
                </c:pt>
                <c:pt idx="44">
                  <c:v>1.111456</c:v>
                </c:pt>
                <c:pt idx="45">
                  <c:v>0.74534520000000004</c:v>
                </c:pt>
                <c:pt idx="46">
                  <c:v>0.80749420000000005</c:v>
                </c:pt>
                <c:pt idx="47">
                  <c:v>0.55006200000000005</c:v>
                </c:pt>
                <c:pt idx="48">
                  <c:v>0.56247789999999998</c:v>
                </c:pt>
                <c:pt idx="49">
                  <c:v>1.404833</c:v>
                </c:pt>
                <c:pt idx="50">
                  <c:v>2.4435989999999999</c:v>
                </c:pt>
                <c:pt idx="51">
                  <c:v>0.61102619999999996</c:v>
                </c:pt>
                <c:pt idx="52">
                  <c:v>0.70341549999999997</c:v>
                </c:pt>
                <c:pt idx="53">
                  <c:v>1.746526</c:v>
                </c:pt>
                <c:pt idx="54">
                  <c:v>0.54059349999999995</c:v>
                </c:pt>
                <c:pt idx="55">
                  <c:v>0.41837400000000002</c:v>
                </c:pt>
                <c:pt idx="56">
                  <c:v>2.047488</c:v>
                </c:pt>
                <c:pt idx="57">
                  <c:v>1.333942</c:v>
                </c:pt>
                <c:pt idx="58">
                  <c:v>0.62505544999999996</c:v>
                </c:pt>
                <c:pt idx="59">
                  <c:v>0.56525530000000002</c:v>
                </c:pt>
                <c:pt idx="60">
                  <c:v>0.41951050000000001</c:v>
                </c:pt>
                <c:pt idx="61">
                  <c:v>1.1259520000000001</c:v>
                </c:pt>
                <c:pt idx="62">
                  <c:v>1.1247670000000001</c:v>
                </c:pt>
                <c:pt idx="63">
                  <c:v>1.6245350000000001</c:v>
                </c:pt>
                <c:pt idx="64">
                  <c:v>1.4592849999999999</c:v>
                </c:pt>
                <c:pt idx="65">
                  <c:v>0.4008274</c:v>
                </c:pt>
                <c:pt idx="66">
                  <c:v>0.61339860000000002</c:v>
                </c:pt>
                <c:pt idx="67">
                  <c:v>1.7113640000000001</c:v>
                </c:pt>
                <c:pt idx="68">
                  <c:v>1.327723</c:v>
                </c:pt>
                <c:pt idx="69">
                  <c:v>0.49193409999999999</c:v>
                </c:pt>
                <c:pt idx="70">
                  <c:v>0.83761359999999996</c:v>
                </c:pt>
                <c:pt idx="71">
                  <c:v>0.5864047</c:v>
                </c:pt>
                <c:pt idx="72">
                  <c:v>0.38550499999999999</c:v>
                </c:pt>
                <c:pt idx="73">
                  <c:v>0.46716279999999999</c:v>
                </c:pt>
                <c:pt idx="74">
                  <c:v>0.7814797</c:v>
                </c:pt>
                <c:pt idx="75">
                  <c:v>1.7508300000000001</c:v>
                </c:pt>
                <c:pt idx="76">
                  <c:v>1.039663</c:v>
                </c:pt>
                <c:pt idx="77">
                  <c:v>0.54914569999999996</c:v>
                </c:pt>
                <c:pt idx="78">
                  <c:v>0.53828030000000004</c:v>
                </c:pt>
                <c:pt idx="79">
                  <c:v>0.51976310000000003</c:v>
                </c:pt>
                <c:pt idx="80">
                  <c:v>1.8933869999999999</c:v>
                </c:pt>
                <c:pt idx="81">
                  <c:v>0.56092575</c:v>
                </c:pt>
                <c:pt idx="82">
                  <c:v>1.0511360000000001</c:v>
                </c:pt>
                <c:pt idx="83">
                  <c:v>1.0150999999999999</c:v>
                </c:pt>
                <c:pt idx="84">
                  <c:v>0.60850249999999995</c:v>
                </c:pt>
                <c:pt idx="85">
                  <c:v>1.412838</c:v>
                </c:pt>
                <c:pt idx="86">
                  <c:v>0.60850249999999995</c:v>
                </c:pt>
                <c:pt idx="87">
                  <c:v>1.550975</c:v>
                </c:pt>
                <c:pt idx="88">
                  <c:v>1.079202</c:v>
                </c:pt>
                <c:pt idx="89">
                  <c:v>1.801366</c:v>
                </c:pt>
                <c:pt idx="90">
                  <c:v>1.981573</c:v>
                </c:pt>
                <c:pt idx="91">
                  <c:v>1.8152520000000001</c:v>
                </c:pt>
                <c:pt idx="92">
                  <c:v>1.6445524</c:v>
                </c:pt>
                <c:pt idx="93">
                  <c:v>1.485114</c:v>
                </c:pt>
                <c:pt idx="94">
                  <c:v>1.3560289999999999</c:v>
                </c:pt>
                <c:pt idx="95">
                  <c:v>1.4331959999999999</c:v>
                </c:pt>
                <c:pt idx="96">
                  <c:v>1.8685780000000001</c:v>
                </c:pt>
                <c:pt idx="97">
                  <c:v>1.3429310000000001</c:v>
                </c:pt>
                <c:pt idx="98">
                  <c:v>0.82275659999999995</c:v>
                </c:pt>
                <c:pt idx="99">
                  <c:v>1.5906800000000001</c:v>
                </c:pt>
                <c:pt idx="100">
                  <c:v>1.7352939999999999</c:v>
                </c:pt>
                <c:pt idx="101">
                  <c:v>4.7312079999999996</c:v>
                </c:pt>
                <c:pt idx="102">
                  <c:v>1.833771</c:v>
                </c:pt>
                <c:pt idx="103">
                  <c:v>2.129848</c:v>
                </c:pt>
                <c:pt idx="104">
                  <c:v>0.93802149999999995</c:v>
                </c:pt>
                <c:pt idx="105">
                  <c:v>1.123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7229072"/>
        <c:axId val="187229456"/>
      </c:scatterChart>
      <c:valAx>
        <c:axId val="18722907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orm_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229456"/>
        <c:crosses val="autoZero"/>
        <c:crossBetween val="midCat"/>
      </c:valAx>
      <c:valAx>
        <c:axId val="18722945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veLogFC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229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veLogFC vs RTI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6!$L$6</c:f>
              <c:strCache>
                <c:ptCount val="1"/>
                <c:pt idx="0">
                  <c:v>AveLogFC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6!$C$7:$C$112</c:f>
              <c:numCache>
                <c:formatCode>General</c:formatCode>
                <c:ptCount val="106"/>
                <c:pt idx="0">
                  <c:v>0.46500000000000002</c:v>
                </c:pt>
                <c:pt idx="1">
                  <c:v>0.29899999999999999</c:v>
                </c:pt>
                <c:pt idx="2">
                  <c:v>0.20100000000000001</c:v>
                </c:pt>
                <c:pt idx="3">
                  <c:v>0.19500000000000001</c:v>
                </c:pt>
                <c:pt idx="4">
                  <c:v>0.193</c:v>
                </c:pt>
                <c:pt idx="5">
                  <c:v>0.16800000000000001</c:v>
                </c:pt>
                <c:pt idx="6">
                  <c:v>0.16200000000000001</c:v>
                </c:pt>
                <c:pt idx="7">
                  <c:v>0.16200000000000001</c:v>
                </c:pt>
                <c:pt idx="8">
                  <c:v>0.154</c:v>
                </c:pt>
                <c:pt idx="9">
                  <c:v>0.14399999999999999</c:v>
                </c:pt>
                <c:pt idx="10">
                  <c:v>0.14099999999999999</c:v>
                </c:pt>
                <c:pt idx="11">
                  <c:v>0.127</c:v>
                </c:pt>
                <c:pt idx="12">
                  <c:v>0.10299999999999999</c:v>
                </c:pt>
                <c:pt idx="13">
                  <c:v>0.10199999999999999</c:v>
                </c:pt>
                <c:pt idx="14">
                  <c:v>9.8000000000000004E-2</c:v>
                </c:pt>
                <c:pt idx="15">
                  <c:v>9.4E-2</c:v>
                </c:pt>
                <c:pt idx="16">
                  <c:v>9.4E-2</c:v>
                </c:pt>
                <c:pt idx="17">
                  <c:v>9.1999999999999998E-2</c:v>
                </c:pt>
                <c:pt idx="18">
                  <c:v>8.5000000000000006E-2</c:v>
                </c:pt>
                <c:pt idx="19">
                  <c:v>7.5999999999999998E-2</c:v>
                </c:pt>
                <c:pt idx="20">
                  <c:v>7.5999999999999998E-2</c:v>
                </c:pt>
                <c:pt idx="21">
                  <c:v>7.1999999999999995E-2</c:v>
                </c:pt>
                <c:pt idx="22">
                  <c:v>6.5000000000000002E-2</c:v>
                </c:pt>
                <c:pt idx="23">
                  <c:v>6.3E-2</c:v>
                </c:pt>
                <c:pt idx="24">
                  <c:v>5.8999999999999997E-2</c:v>
                </c:pt>
                <c:pt idx="25">
                  <c:v>5.2999999999999999E-2</c:v>
                </c:pt>
                <c:pt idx="26">
                  <c:v>5.2999999999999999E-2</c:v>
                </c:pt>
                <c:pt idx="27">
                  <c:v>5.1999999999999998E-2</c:v>
                </c:pt>
                <c:pt idx="28">
                  <c:v>0.05</c:v>
                </c:pt>
                <c:pt idx="29">
                  <c:v>4.3999999999999997E-2</c:v>
                </c:pt>
                <c:pt idx="30">
                  <c:v>4.2999999999999997E-2</c:v>
                </c:pt>
                <c:pt idx="31">
                  <c:v>4.2000000000000003E-2</c:v>
                </c:pt>
                <c:pt idx="32">
                  <c:v>4.2000000000000003E-2</c:v>
                </c:pt>
                <c:pt idx="33">
                  <c:v>0.04</c:v>
                </c:pt>
                <c:pt idx="34">
                  <c:v>3.5999999999999997E-2</c:v>
                </c:pt>
                <c:pt idx="35">
                  <c:v>2.7E-2</c:v>
                </c:pt>
                <c:pt idx="36">
                  <c:v>2.7E-2</c:v>
                </c:pt>
                <c:pt idx="37">
                  <c:v>2.1000000000000001E-2</c:v>
                </c:pt>
                <c:pt idx="38">
                  <c:v>2.1000000000000001E-2</c:v>
                </c:pt>
                <c:pt idx="39">
                  <c:v>2.1000000000000001E-2</c:v>
                </c:pt>
                <c:pt idx="40">
                  <c:v>0.02</c:v>
                </c:pt>
                <c:pt idx="41">
                  <c:v>1.9E-2</c:v>
                </c:pt>
                <c:pt idx="42">
                  <c:v>1.9E-2</c:v>
                </c:pt>
                <c:pt idx="43">
                  <c:v>1.7999999999999999E-2</c:v>
                </c:pt>
                <c:pt idx="44">
                  <c:v>1.7999999999999999E-2</c:v>
                </c:pt>
                <c:pt idx="45">
                  <c:v>1.7999999999999999E-2</c:v>
                </c:pt>
                <c:pt idx="46">
                  <c:v>1.7999999999999999E-2</c:v>
                </c:pt>
                <c:pt idx="47">
                  <c:v>1.7000000000000001E-2</c:v>
                </c:pt>
                <c:pt idx="48">
                  <c:v>1.6E-2</c:v>
                </c:pt>
                <c:pt idx="49">
                  <c:v>1.6E-2</c:v>
                </c:pt>
                <c:pt idx="50">
                  <c:v>1.4999999999999999E-2</c:v>
                </c:pt>
                <c:pt idx="51">
                  <c:v>1.4E-2</c:v>
                </c:pt>
                <c:pt idx="52">
                  <c:v>1.4E-2</c:v>
                </c:pt>
                <c:pt idx="53">
                  <c:v>1.2999999999999999E-2</c:v>
                </c:pt>
                <c:pt idx="54">
                  <c:v>1.2999999999999999E-2</c:v>
                </c:pt>
                <c:pt idx="55">
                  <c:v>1.2999999999999999E-2</c:v>
                </c:pt>
                <c:pt idx="56">
                  <c:v>1.2E-2</c:v>
                </c:pt>
                <c:pt idx="57">
                  <c:v>1.2E-2</c:v>
                </c:pt>
                <c:pt idx="58">
                  <c:v>1.2E-2</c:v>
                </c:pt>
                <c:pt idx="59">
                  <c:v>8.9999999999999993E-3</c:v>
                </c:pt>
                <c:pt idx="60">
                  <c:v>8.0000000000000002E-3</c:v>
                </c:pt>
                <c:pt idx="61">
                  <c:v>8.0000000000000002E-3</c:v>
                </c:pt>
                <c:pt idx="62">
                  <c:v>8.0000000000000002E-3</c:v>
                </c:pt>
                <c:pt idx="63">
                  <c:v>7.0000000000000001E-3</c:v>
                </c:pt>
                <c:pt idx="64">
                  <c:v>7.0000000000000001E-3</c:v>
                </c:pt>
                <c:pt idx="65">
                  <c:v>6.0000000000000001E-3</c:v>
                </c:pt>
                <c:pt idx="66">
                  <c:v>6.0000000000000001E-3</c:v>
                </c:pt>
                <c:pt idx="67">
                  <c:v>5.0000000000000001E-3</c:v>
                </c:pt>
                <c:pt idx="68">
                  <c:v>5.0000000000000001E-3</c:v>
                </c:pt>
                <c:pt idx="69">
                  <c:v>5.0000000000000001E-3</c:v>
                </c:pt>
                <c:pt idx="70">
                  <c:v>5.0000000000000001E-3</c:v>
                </c:pt>
                <c:pt idx="71">
                  <c:v>4.0000000000000001E-3</c:v>
                </c:pt>
                <c:pt idx="72">
                  <c:v>4.0000000000000001E-3</c:v>
                </c:pt>
                <c:pt idx="73">
                  <c:v>4.0000000000000001E-3</c:v>
                </c:pt>
                <c:pt idx="74">
                  <c:v>4.0000000000000001E-3</c:v>
                </c:pt>
                <c:pt idx="75">
                  <c:v>4.0000000000000001E-3</c:v>
                </c:pt>
                <c:pt idx="76">
                  <c:v>4.0000000000000001E-3</c:v>
                </c:pt>
                <c:pt idx="77">
                  <c:v>3.0000000000000001E-3</c:v>
                </c:pt>
                <c:pt idx="78">
                  <c:v>3.0000000000000001E-3</c:v>
                </c:pt>
                <c:pt idx="79">
                  <c:v>3.0000000000000001E-3</c:v>
                </c:pt>
                <c:pt idx="80">
                  <c:v>3.0000000000000001E-3</c:v>
                </c:pt>
                <c:pt idx="81">
                  <c:v>3.0000000000000001E-3</c:v>
                </c:pt>
                <c:pt idx="82">
                  <c:v>3.0000000000000001E-3</c:v>
                </c:pt>
                <c:pt idx="83">
                  <c:v>3.0000000000000001E-3</c:v>
                </c:pt>
                <c:pt idx="84">
                  <c:v>3.0000000000000001E-3</c:v>
                </c:pt>
                <c:pt idx="85">
                  <c:v>2E-3</c:v>
                </c:pt>
                <c:pt idx="86">
                  <c:v>2E-3</c:v>
                </c:pt>
                <c:pt idx="87">
                  <c:v>2E-3</c:v>
                </c:pt>
                <c:pt idx="88">
                  <c:v>2E-3</c:v>
                </c:pt>
                <c:pt idx="89">
                  <c:v>2E-3</c:v>
                </c:pt>
                <c:pt idx="90">
                  <c:v>2E-3</c:v>
                </c:pt>
                <c:pt idx="91">
                  <c:v>2E-3</c:v>
                </c:pt>
                <c:pt idx="92">
                  <c:v>2E-3</c:v>
                </c:pt>
                <c:pt idx="93">
                  <c:v>1E-3</c:v>
                </c:pt>
                <c:pt idx="94">
                  <c:v>1E-3</c:v>
                </c:pt>
                <c:pt idx="95">
                  <c:v>1E-3</c:v>
                </c:pt>
                <c:pt idx="96">
                  <c:v>1E-3</c:v>
                </c:pt>
                <c:pt idx="97">
                  <c:v>1E-3</c:v>
                </c:pt>
                <c:pt idx="98">
                  <c:v>1E-3</c:v>
                </c:pt>
                <c:pt idx="99">
                  <c:v>1E-3</c:v>
                </c:pt>
                <c:pt idx="100">
                  <c:v>1E-3</c:v>
                </c:pt>
                <c:pt idx="101">
                  <c:v>1E-3</c:v>
                </c:pt>
                <c:pt idx="102">
                  <c:v>1E-3</c:v>
                </c:pt>
                <c:pt idx="103">
                  <c:v>1E-3</c:v>
                </c:pt>
                <c:pt idx="104">
                  <c:v>1E-3</c:v>
                </c:pt>
                <c:pt idx="105">
                  <c:v>1E-3</c:v>
                </c:pt>
              </c:numCache>
            </c:numRef>
          </c:xVal>
          <c:yVal>
            <c:numRef>
              <c:f>Sheet6!$L$7:$L$112</c:f>
              <c:numCache>
                <c:formatCode>General</c:formatCode>
                <c:ptCount val="106"/>
                <c:pt idx="0">
                  <c:v>0.4916683</c:v>
                </c:pt>
                <c:pt idx="1">
                  <c:v>1.3601939999999999</c:v>
                </c:pt>
                <c:pt idx="2">
                  <c:v>0.62505544999999996</c:v>
                </c:pt>
                <c:pt idx="3">
                  <c:v>0.56833235000000004</c:v>
                </c:pt>
                <c:pt idx="4">
                  <c:v>0.91419260000000002</c:v>
                </c:pt>
                <c:pt idx="5">
                  <c:v>0.61132149999999996</c:v>
                </c:pt>
                <c:pt idx="6">
                  <c:v>0.4008274</c:v>
                </c:pt>
                <c:pt idx="7">
                  <c:v>0.61339860000000002</c:v>
                </c:pt>
                <c:pt idx="8">
                  <c:v>0.51797219999999999</c:v>
                </c:pt>
                <c:pt idx="9">
                  <c:v>0.56833235000000004</c:v>
                </c:pt>
                <c:pt idx="10">
                  <c:v>1.6445524</c:v>
                </c:pt>
                <c:pt idx="11">
                  <c:v>0.40994390000000003</c:v>
                </c:pt>
                <c:pt idx="12">
                  <c:v>0.40994390000000003</c:v>
                </c:pt>
                <c:pt idx="13">
                  <c:v>0.69967780000000002</c:v>
                </c:pt>
                <c:pt idx="14">
                  <c:v>1.192707</c:v>
                </c:pt>
                <c:pt idx="15">
                  <c:v>0.4273825</c:v>
                </c:pt>
                <c:pt idx="16">
                  <c:v>0.4347569</c:v>
                </c:pt>
                <c:pt idx="17">
                  <c:v>0.93560125000000005</c:v>
                </c:pt>
                <c:pt idx="18">
                  <c:v>0.71165730000000005</c:v>
                </c:pt>
                <c:pt idx="19">
                  <c:v>0.46716279999999999</c:v>
                </c:pt>
                <c:pt idx="20">
                  <c:v>0.7814797</c:v>
                </c:pt>
                <c:pt idx="21">
                  <c:v>1.5586838999999999</c:v>
                </c:pt>
                <c:pt idx="22">
                  <c:v>0.56833235000000004</c:v>
                </c:pt>
                <c:pt idx="23">
                  <c:v>0.57281780000000004</c:v>
                </c:pt>
                <c:pt idx="24">
                  <c:v>1.5586838999999999</c:v>
                </c:pt>
                <c:pt idx="25">
                  <c:v>0.85598819999999998</c:v>
                </c:pt>
                <c:pt idx="26">
                  <c:v>1.229508</c:v>
                </c:pt>
                <c:pt idx="27">
                  <c:v>0.93560125000000005</c:v>
                </c:pt>
                <c:pt idx="28">
                  <c:v>1.711883</c:v>
                </c:pt>
                <c:pt idx="29">
                  <c:v>1.0264759999999999</c:v>
                </c:pt>
                <c:pt idx="30">
                  <c:v>0.71161350000000001</c:v>
                </c:pt>
                <c:pt idx="31">
                  <c:v>0.49193409999999999</c:v>
                </c:pt>
                <c:pt idx="32">
                  <c:v>0.83761359999999996</c:v>
                </c:pt>
                <c:pt idx="33">
                  <c:v>0.69904520000000003</c:v>
                </c:pt>
                <c:pt idx="34">
                  <c:v>0.74534520000000004</c:v>
                </c:pt>
                <c:pt idx="35">
                  <c:v>0.56833235000000004</c:v>
                </c:pt>
                <c:pt idx="36">
                  <c:v>0.8486591</c:v>
                </c:pt>
                <c:pt idx="37">
                  <c:v>0.67366510000000002</c:v>
                </c:pt>
                <c:pt idx="38">
                  <c:v>0.48918840000000002</c:v>
                </c:pt>
                <c:pt idx="39">
                  <c:v>1.821731</c:v>
                </c:pt>
                <c:pt idx="40">
                  <c:v>0.51500349999999995</c:v>
                </c:pt>
                <c:pt idx="41">
                  <c:v>0.76376999999999995</c:v>
                </c:pt>
                <c:pt idx="42">
                  <c:v>0.34944439999999999</c:v>
                </c:pt>
                <c:pt idx="43">
                  <c:v>0.61132149999999996</c:v>
                </c:pt>
                <c:pt idx="44">
                  <c:v>1.111456</c:v>
                </c:pt>
                <c:pt idx="45">
                  <c:v>0.74534520000000004</c:v>
                </c:pt>
                <c:pt idx="46">
                  <c:v>0.80749420000000005</c:v>
                </c:pt>
                <c:pt idx="47">
                  <c:v>0.55006200000000005</c:v>
                </c:pt>
                <c:pt idx="48">
                  <c:v>0.56247789999999998</c:v>
                </c:pt>
                <c:pt idx="49">
                  <c:v>1.404833</c:v>
                </c:pt>
                <c:pt idx="50">
                  <c:v>2.4435989999999999</c:v>
                </c:pt>
                <c:pt idx="51">
                  <c:v>0.61102619999999996</c:v>
                </c:pt>
                <c:pt idx="52">
                  <c:v>0.70341549999999997</c:v>
                </c:pt>
                <c:pt idx="53">
                  <c:v>1.746526</c:v>
                </c:pt>
                <c:pt idx="54">
                  <c:v>0.54059349999999995</c:v>
                </c:pt>
                <c:pt idx="55">
                  <c:v>0.41837400000000002</c:v>
                </c:pt>
                <c:pt idx="56">
                  <c:v>2.047488</c:v>
                </c:pt>
                <c:pt idx="57">
                  <c:v>1.333942</c:v>
                </c:pt>
                <c:pt idx="58">
                  <c:v>0.62505544999999996</c:v>
                </c:pt>
                <c:pt idx="59">
                  <c:v>0.56525530000000002</c:v>
                </c:pt>
                <c:pt idx="60">
                  <c:v>0.41951050000000001</c:v>
                </c:pt>
                <c:pt idx="61">
                  <c:v>1.1259520000000001</c:v>
                </c:pt>
                <c:pt idx="62">
                  <c:v>1.1247670000000001</c:v>
                </c:pt>
                <c:pt idx="63">
                  <c:v>1.6245350000000001</c:v>
                </c:pt>
                <c:pt idx="64">
                  <c:v>1.4592849999999999</c:v>
                </c:pt>
                <c:pt idx="65">
                  <c:v>0.4008274</c:v>
                </c:pt>
                <c:pt idx="66">
                  <c:v>0.61339860000000002</c:v>
                </c:pt>
                <c:pt idx="67">
                  <c:v>1.7113640000000001</c:v>
                </c:pt>
                <c:pt idx="68">
                  <c:v>1.327723</c:v>
                </c:pt>
                <c:pt idx="69">
                  <c:v>0.49193409999999999</c:v>
                </c:pt>
                <c:pt idx="70">
                  <c:v>0.83761359999999996</c:v>
                </c:pt>
                <c:pt idx="71">
                  <c:v>0.5864047</c:v>
                </c:pt>
                <c:pt idx="72">
                  <c:v>0.38550499999999999</c:v>
                </c:pt>
                <c:pt idx="73">
                  <c:v>0.46716279999999999</c:v>
                </c:pt>
                <c:pt idx="74">
                  <c:v>0.7814797</c:v>
                </c:pt>
                <c:pt idx="75">
                  <c:v>1.7508300000000001</c:v>
                </c:pt>
                <c:pt idx="76">
                  <c:v>1.039663</c:v>
                </c:pt>
                <c:pt idx="77">
                  <c:v>0.54914569999999996</c:v>
                </c:pt>
                <c:pt idx="78">
                  <c:v>0.53828030000000004</c:v>
                </c:pt>
                <c:pt idx="79">
                  <c:v>0.51976310000000003</c:v>
                </c:pt>
                <c:pt idx="80">
                  <c:v>1.8933869999999999</c:v>
                </c:pt>
                <c:pt idx="81">
                  <c:v>0.56092575</c:v>
                </c:pt>
                <c:pt idx="82">
                  <c:v>1.0511360000000001</c:v>
                </c:pt>
                <c:pt idx="83">
                  <c:v>1.0150999999999999</c:v>
                </c:pt>
                <c:pt idx="84">
                  <c:v>0.60850249999999995</c:v>
                </c:pt>
                <c:pt idx="85">
                  <c:v>1.412838</c:v>
                </c:pt>
                <c:pt idx="86">
                  <c:v>0.60850249999999995</c:v>
                </c:pt>
                <c:pt idx="87">
                  <c:v>1.550975</c:v>
                </c:pt>
                <c:pt idx="88">
                  <c:v>1.079202</c:v>
                </c:pt>
                <c:pt idx="89">
                  <c:v>1.801366</c:v>
                </c:pt>
                <c:pt idx="90">
                  <c:v>1.981573</c:v>
                </c:pt>
                <c:pt idx="91">
                  <c:v>1.8152520000000001</c:v>
                </c:pt>
                <c:pt idx="92">
                  <c:v>1.6445524</c:v>
                </c:pt>
                <c:pt idx="93">
                  <c:v>1.485114</c:v>
                </c:pt>
                <c:pt idx="94">
                  <c:v>1.3560289999999999</c:v>
                </c:pt>
                <c:pt idx="95">
                  <c:v>1.4331959999999999</c:v>
                </c:pt>
                <c:pt idx="96">
                  <c:v>1.8685780000000001</c:v>
                </c:pt>
                <c:pt idx="97">
                  <c:v>1.3429310000000001</c:v>
                </c:pt>
                <c:pt idx="98">
                  <c:v>0.82275659999999995</c:v>
                </c:pt>
                <c:pt idx="99">
                  <c:v>1.5906800000000001</c:v>
                </c:pt>
                <c:pt idx="100">
                  <c:v>1.7352939999999999</c:v>
                </c:pt>
                <c:pt idx="101">
                  <c:v>4.7312079999999996</c:v>
                </c:pt>
                <c:pt idx="102">
                  <c:v>1.833771</c:v>
                </c:pt>
                <c:pt idx="103">
                  <c:v>2.129848</c:v>
                </c:pt>
                <c:pt idx="104">
                  <c:v>0.93802149999999995</c:v>
                </c:pt>
                <c:pt idx="105">
                  <c:v>1.1237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751632"/>
        <c:axId val="186754064"/>
      </c:scatterChart>
      <c:valAx>
        <c:axId val="1867516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T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754064"/>
        <c:crosses val="autoZero"/>
        <c:crossBetween val="midCat"/>
      </c:valAx>
      <c:valAx>
        <c:axId val="1867540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AveLogFC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75163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Norm_Score vs RTI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Sheet6!$J$6</c:f>
              <c:strCache>
                <c:ptCount val="1"/>
                <c:pt idx="0">
                  <c:v>Norm_Scor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Sheet6!$C$7:$C$112</c:f>
              <c:numCache>
                <c:formatCode>General</c:formatCode>
                <c:ptCount val="106"/>
                <c:pt idx="0">
                  <c:v>0.46500000000000002</c:v>
                </c:pt>
                <c:pt idx="1">
                  <c:v>0.29899999999999999</c:v>
                </c:pt>
                <c:pt idx="2">
                  <c:v>0.20100000000000001</c:v>
                </c:pt>
                <c:pt idx="3">
                  <c:v>0.19500000000000001</c:v>
                </c:pt>
                <c:pt idx="4">
                  <c:v>0.193</c:v>
                </c:pt>
                <c:pt idx="5">
                  <c:v>0.16800000000000001</c:v>
                </c:pt>
                <c:pt idx="6">
                  <c:v>0.16200000000000001</c:v>
                </c:pt>
                <c:pt idx="7">
                  <c:v>0.16200000000000001</c:v>
                </c:pt>
                <c:pt idx="8">
                  <c:v>0.154</c:v>
                </c:pt>
                <c:pt idx="9">
                  <c:v>0.14399999999999999</c:v>
                </c:pt>
                <c:pt idx="10">
                  <c:v>0.14099999999999999</c:v>
                </c:pt>
                <c:pt idx="11">
                  <c:v>0.127</c:v>
                </c:pt>
                <c:pt idx="12">
                  <c:v>0.10299999999999999</c:v>
                </c:pt>
                <c:pt idx="13">
                  <c:v>0.10199999999999999</c:v>
                </c:pt>
                <c:pt idx="14">
                  <c:v>9.8000000000000004E-2</c:v>
                </c:pt>
                <c:pt idx="15">
                  <c:v>9.4E-2</c:v>
                </c:pt>
                <c:pt idx="16">
                  <c:v>9.4E-2</c:v>
                </c:pt>
                <c:pt idx="17">
                  <c:v>9.1999999999999998E-2</c:v>
                </c:pt>
                <c:pt idx="18">
                  <c:v>8.5000000000000006E-2</c:v>
                </c:pt>
                <c:pt idx="19">
                  <c:v>7.5999999999999998E-2</c:v>
                </c:pt>
                <c:pt idx="20">
                  <c:v>7.5999999999999998E-2</c:v>
                </c:pt>
                <c:pt idx="21">
                  <c:v>7.1999999999999995E-2</c:v>
                </c:pt>
                <c:pt idx="22">
                  <c:v>6.5000000000000002E-2</c:v>
                </c:pt>
                <c:pt idx="23">
                  <c:v>6.3E-2</c:v>
                </c:pt>
                <c:pt idx="24">
                  <c:v>5.8999999999999997E-2</c:v>
                </c:pt>
                <c:pt idx="25">
                  <c:v>5.2999999999999999E-2</c:v>
                </c:pt>
                <c:pt idx="26">
                  <c:v>5.2999999999999999E-2</c:v>
                </c:pt>
                <c:pt idx="27">
                  <c:v>5.1999999999999998E-2</c:v>
                </c:pt>
                <c:pt idx="28">
                  <c:v>0.05</c:v>
                </c:pt>
                <c:pt idx="29">
                  <c:v>4.3999999999999997E-2</c:v>
                </c:pt>
                <c:pt idx="30">
                  <c:v>4.2999999999999997E-2</c:v>
                </c:pt>
                <c:pt idx="31">
                  <c:v>4.2000000000000003E-2</c:v>
                </c:pt>
                <c:pt idx="32">
                  <c:v>4.2000000000000003E-2</c:v>
                </c:pt>
                <c:pt idx="33">
                  <c:v>0.04</c:v>
                </c:pt>
                <c:pt idx="34">
                  <c:v>3.5999999999999997E-2</c:v>
                </c:pt>
                <c:pt idx="35">
                  <c:v>2.7E-2</c:v>
                </c:pt>
                <c:pt idx="36">
                  <c:v>2.7E-2</c:v>
                </c:pt>
                <c:pt idx="37">
                  <c:v>2.1000000000000001E-2</c:v>
                </c:pt>
                <c:pt idx="38">
                  <c:v>2.1000000000000001E-2</c:v>
                </c:pt>
                <c:pt idx="39">
                  <c:v>2.1000000000000001E-2</c:v>
                </c:pt>
                <c:pt idx="40">
                  <c:v>0.02</c:v>
                </c:pt>
                <c:pt idx="41">
                  <c:v>1.9E-2</c:v>
                </c:pt>
                <c:pt idx="42">
                  <c:v>1.9E-2</c:v>
                </c:pt>
                <c:pt idx="43">
                  <c:v>1.7999999999999999E-2</c:v>
                </c:pt>
                <c:pt idx="44">
                  <c:v>1.7999999999999999E-2</c:v>
                </c:pt>
                <c:pt idx="45">
                  <c:v>1.7999999999999999E-2</c:v>
                </c:pt>
                <c:pt idx="46">
                  <c:v>1.7999999999999999E-2</c:v>
                </c:pt>
                <c:pt idx="47">
                  <c:v>1.7000000000000001E-2</c:v>
                </c:pt>
                <c:pt idx="48">
                  <c:v>1.6E-2</c:v>
                </c:pt>
                <c:pt idx="49">
                  <c:v>1.6E-2</c:v>
                </c:pt>
                <c:pt idx="50">
                  <c:v>1.4999999999999999E-2</c:v>
                </c:pt>
                <c:pt idx="51">
                  <c:v>1.4E-2</c:v>
                </c:pt>
                <c:pt idx="52">
                  <c:v>1.4E-2</c:v>
                </c:pt>
                <c:pt idx="53">
                  <c:v>1.2999999999999999E-2</c:v>
                </c:pt>
                <c:pt idx="54">
                  <c:v>1.2999999999999999E-2</c:v>
                </c:pt>
                <c:pt idx="55">
                  <c:v>1.2999999999999999E-2</c:v>
                </c:pt>
                <c:pt idx="56">
                  <c:v>1.2E-2</c:v>
                </c:pt>
                <c:pt idx="57">
                  <c:v>1.2E-2</c:v>
                </c:pt>
                <c:pt idx="58">
                  <c:v>1.2E-2</c:v>
                </c:pt>
                <c:pt idx="59">
                  <c:v>8.9999999999999993E-3</c:v>
                </c:pt>
                <c:pt idx="60">
                  <c:v>8.0000000000000002E-3</c:v>
                </c:pt>
                <c:pt idx="61">
                  <c:v>8.0000000000000002E-3</c:v>
                </c:pt>
                <c:pt idx="62">
                  <c:v>8.0000000000000002E-3</c:v>
                </c:pt>
                <c:pt idx="63">
                  <c:v>7.0000000000000001E-3</c:v>
                </c:pt>
                <c:pt idx="64">
                  <c:v>7.0000000000000001E-3</c:v>
                </c:pt>
                <c:pt idx="65">
                  <c:v>6.0000000000000001E-3</c:v>
                </c:pt>
                <c:pt idx="66">
                  <c:v>6.0000000000000001E-3</c:v>
                </c:pt>
                <c:pt idx="67">
                  <c:v>5.0000000000000001E-3</c:v>
                </c:pt>
                <c:pt idx="68">
                  <c:v>5.0000000000000001E-3</c:v>
                </c:pt>
                <c:pt idx="69">
                  <c:v>5.0000000000000001E-3</c:v>
                </c:pt>
                <c:pt idx="70">
                  <c:v>5.0000000000000001E-3</c:v>
                </c:pt>
                <c:pt idx="71">
                  <c:v>4.0000000000000001E-3</c:v>
                </c:pt>
                <c:pt idx="72">
                  <c:v>4.0000000000000001E-3</c:v>
                </c:pt>
                <c:pt idx="73">
                  <c:v>4.0000000000000001E-3</c:v>
                </c:pt>
                <c:pt idx="74">
                  <c:v>4.0000000000000001E-3</c:v>
                </c:pt>
                <c:pt idx="75">
                  <c:v>4.0000000000000001E-3</c:v>
                </c:pt>
                <c:pt idx="76">
                  <c:v>4.0000000000000001E-3</c:v>
                </c:pt>
                <c:pt idx="77">
                  <c:v>3.0000000000000001E-3</c:v>
                </c:pt>
                <c:pt idx="78">
                  <c:v>3.0000000000000001E-3</c:v>
                </c:pt>
                <c:pt idx="79">
                  <c:v>3.0000000000000001E-3</c:v>
                </c:pt>
                <c:pt idx="80">
                  <c:v>3.0000000000000001E-3</c:v>
                </c:pt>
                <c:pt idx="81">
                  <c:v>3.0000000000000001E-3</c:v>
                </c:pt>
                <c:pt idx="82">
                  <c:v>3.0000000000000001E-3</c:v>
                </c:pt>
                <c:pt idx="83">
                  <c:v>3.0000000000000001E-3</c:v>
                </c:pt>
                <c:pt idx="84">
                  <c:v>3.0000000000000001E-3</c:v>
                </c:pt>
                <c:pt idx="85">
                  <c:v>2E-3</c:v>
                </c:pt>
                <c:pt idx="86">
                  <c:v>2E-3</c:v>
                </c:pt>
                <c:pt idx="87">
                  <c:v>2E-3</c:v>
                </c:pt>
                <c:pt idx="88">
                  <c:v>2E-3</c:v>
                </c:pt>
                <c:pt idx="89">
                  <c:v>2E-3</c:v>
                </c:pt>
                <c:pt idx="90">
                  <c:v>2E-3</c:v>
                </c:pt>
                <c:pt idx="91">
                  <c:v>2E-3</c:v>
                </c:pt>
                <c:pt idx="92">
                  <c:v>2E-3</c:v>
                </c:pt>
                <c:pt idx="93">
                  <c:v>1E-3</c:v>
                </c:pt>
                <c:pt idx="94">
                  <c:v>1E-3</c:v>
                </c:pt>
                <c:pt idx="95">
                  <c:v>1E-3</c:v>
                </c:pt>
                <c:pt idx="96">
                  <c:v>1E-3</c:v>
                </c:pt>
                <c:pt idx="97">
                  <c:v>1E-3</c:v>
                </c:pt>
                <c:pt idx="98">
                  <c:v>1E-3</c:v>
                </c:pt>
                <c:pt idx="99">
                  <c:v>1E-3</c:v>
                </c:pt>
                <c:pt idx="100">
                  <c:v>1E-3</c:v>
                </c:pt>
                <c:pt idx="101">
                  <c:v>1E-3</c:v>
                </c:pt>
                <c:pt idx="102">
                  <c:v>1E-3</c:v>
                </c:pt>
                <c:pt idx="103">
                  <c:v>1E-3</c:v>
                </c:pt>
                <c:pt idx="104">
                  <c:v>1E-3</c:v>
                </c:pt>
                <c:pt idx="105">
                  <c:v>1E-3</c:v>
                </c:pt>
              </c:numCache>
            </c:numRef>
          </c:xVal>
          <c:yVal>
            <c:numRef>
              <c:f>Sheet6!$J$7:$J$112</c:f>
              <c:numCache>
                <c:formatCode>General</c:formatCode>
                <c:ptCount val="106"/>
                <c:pt idx="0">
                  <c:v>0.25809880331956303</c:v>
                </c:pt>
                <c:pt idx="1">
                  <c:v>0.21527219352437801</c:v>
                </c:pt>
                <c:pt idx="2">
                  <c:v>0.20361338260515299</c:v>
                </c:pt>
                <c:pt idx="3">
                  <c:v>0.226874222316271</c:v>
                </c:pt>
                <c:pt idx="4">
                  <c:v>0.19919340650262898</c:v>
                </c:pt>
                <c:pt idx="5">
                  <c:v>0.21733990743135098</c:v>
                </c:pt>
                <c:pt idx="6">
                  <c:v>0.18768047845210797</c:v>
                </c:pt>
                <c:pt idx="7">
                  <c:v>0.18768047845210797</c:v>
                </c:pt>
                <c:pt idx="8">
                  <c:v>0.15162826462138501</c:v>
                </c:pt>
                <c:pt idx="9">
                  <c:v>0.226874222316271</c:v>
                </c:pt>
                <c:pt idx="10">
                  <c:v>0.180582215521153</c:v>
                </c:pt>
                <c:pt idx="11">
                  <c:v>0.17580128234332901</c:v>
                </c:pt>
                <c:pt idx="12">
                  <c:v>0.17580128234332901</c:v>
                </c:pt>
                <c:pt idx="13">
                  <c:v>0.13607179660629198</c:v>
                </c:pt>
                <c:pt idx="14">
                  <c:v>0.19099553663033098</c:v>
                </c:pt>
                <c:pt idx="15">
                  <c:v>0.22603837781772601</c:v>
                </c:pt>
                <c:pt idx="16">
                  <c:v>0.27011711960738599</c:v>
                </c:pt>
                <c:pt idx="17">
                  <c:v>0.17965215232127099</c:v>
                </c:pt>
                <c:pt idx="18">
                  <c:v>0.16410191475552799</c:v>
                </c:pt>
                <c:pt idx="19">
                  <c:v>0.20265788992316602</c:v>
                </c:pt>
                <c:pt idx="20">
                  <c:v>0.20265788992316602</c:v>
                </c:pt>
                <c:pt idx="21">
                  <c:v>0.14035954121904001</c:v>
                </c:pt>
                <c:pt idx="22">
                  <c:v>0.226874222316271</c:v>
                </c:pt>
                <c:pt idx="23">
                  <c:v>0.258523199886879</c:v>
                </c:pt>
                <c:pt idx="24">
                  <c:v>0.14035954121904001</c:v>
                </c:pt>
                <c:pt idx="25">
                  <c:v>0.22406903532082001</c:v>
                </c:pt>
                <c:pt idx="26">
                  <c:v>0.10043112464825199</c:v>
                </c:pt>
                <c:pt idx="27">
                  <c:v>0.17965215232127099</c:v>
                </c:pt>
                <c:pt idx="28">
                  <c:v>0.22915370222847201</c:v>
                </c:pt>
                <c:pt idx="29">
                  <c:v>0.216681656690528</c:v>
                </c:pt>
                <c:pt idx="30">
                  <c:v>0.12470518805955899</c:v>
                </c:pt>
                <c:pt idx="31">
                  <c:v>0.18672997442841102</c:v>
                </c:pt>
                <c:pt idx="32">
                  <c:v>0.18672997442841102</c:v>
                </c:pt>
                <c:pt idx="33">
                  <c:v>0.16464099402941598</c:v>
                </c:pt>
                <c:pt idx="34">
                  <c:v>0.21938241223496199</c:v>
                </c:pt>
                <c:pt idx="35">
                  <c:v>0.226874222316271</c:v>
                </c:pt>
                <c:pt idx="36">
                  <c:v>0.14244011914087099</c:v>
                </c:pt>
                <c:pt idx="37">
                  <c:v>0.22112752801215099</c:v>
                </c:pt>
                <c:pt idx="38">
                  <c:v>0.28433715181837999</c:v>
                </c:pt>
                <c:pt idx="39">
                  <c:v>0.202539616111309</c:v>
                </c:pt>
                <c:pt idx="40">
                  <c:v>0.175044815738296</c:v>
                </c:pt>
                <c:pt idx="41">
                  <c:v>0.15721356914988902</c:v>
                </c:pt>
                <c:pt idx="42">
                  <c:v>0.23584496572861099</c:v>
                </c:pt>
                <c:pt idx="43">
                  <c:v>0.21733990743135098</c:v>
                </c:pt>
                <c:pt idx="44">
                  <c:v>0.22089464014316601</c:v>
                </c:pt>
                <c:pt idx="45">
                  <c:v>0.21938241223496199</c:v>
                </c:pt>
                <c:pt idx="46">
                  <c:v>0.228732134381464</c:v>
                </c:pt>
                <c:pt idx="47">
                  <c:v>0.14365630214927599</c:v>
                </c:pt>
                <c:pt idx="48">
                  <c:v>0.26138941480163802</c:v>
                </c:pt>
                <c:pt idx="49">
                  <c:v>0.13961939955534999</c:v>
                </c:pt>
                <c:pt idx="50">
                  <c:v>0.24007901432283202</c:v>
                </c:pt>
                <c:pt idx="51">
                  <c:v>0.24320865833586999</c:v>
                </c:pt>
                <c:pt idx="52">
                  <c:v>0.22315800903046998</c:v>
                </c:pt>
                <c:pt idx="53">
                  <c:v>0.23861874939821601</c:v>
                </c:pt>
                <c:pt idx="54">
                  <c:v>0.187908242768248</c:v>
                </c:pt>
                <c:pt idx="55">
                  <c:v>0.23374248316931698</c:v>
                </c:pt>
                <c:pt idx="56">
                  <c:v>0.21768477138918901</c:v>
                </c:pt>
                <c:pt idx="57">
                  <c:v>0.24349572626935401</c:v>
                </c:pt>
                <c:pt idx="58">
                  <c:v>0.20361338260515299</c:v>
                </c:pt>
                <c:pt idx="59">
                  <c:v>0.28123910104205802</c:v>
                </c:pt>
                <c:pt idx="60">
                  <c:v>0.20989276830490097</c:v>
                </c:pt>
                <c:pt idx="61">
                  <c:v>0.216937376976754</c:v>
                </c:pt>
                <c:pt idx="62">
                  <c:v>0.21318933818452501</c:v>
                </c:pt>
                <c:pt idx="63">
                  <c:v>0.246451173169878</c:v>
                </c:pt>
                <c:pt idx="64">
                  <c:v>0.21041441821283999</c:v>
                </c:pt>
                <c:pt idx="65">
                  <c:v>0.18768047845210797</c:v>
                </c:pt>
                <c:pt idx="66">
                  <c:v>0.18768047845210797</c:v>
                </c:pt>
                <c:pt idx="67">
                  <c:v>0.20755594506170003</c:v>
                </c:pt>
                <c:pt idx="68">
                  <c:v>0.25979671045103331</c:v>
                </c:pt>
                <c:pt idx="69">
                  <c:v>0.18672997442841102</c:v>
                </c:pt>
                <c:pt idx="70">
                  <c:v>0.18672997442841102</c:v>
                </c:pt>
                <c:pt idx="71">
                  <c:v>0.20620837516747417</c:v>
                </c:pt>
                <c:pt idx="72">
                  <c:v>0.2304572623676989</c:v>
                </c:pt>
                <c:pt idx="73">
                  <c:v>0.20265788992316602</c:v>
                </c:pt>
                <c:pt idx="74">
                  <c:v>0.20265788992316602</c:v>
                </c:pt>
                <c:pt idx="75">
                  <c:v>0.13579875598259644</c:v>
                </c:pt>
                <c:pt idx="76">
                  <c:v>0.22297230758653133</c:v>
                </c:pt>
                <c:pt idx="77">
                  <c:v>0.28520508087827728</c:v>
                </c:pt>
                <c:pt idx="78">
                  <c:v>0.26236829892012353</c:v>
                </c:pt>
                <c:pt idx="79">
                  <c:v>0.23805695020735296</c:v>
                </c:pt>
                <c:pt idx="80">
                  <c:v>0.11714346191704689</c:v>
                </c:pt>
                <c:pt idx="81">
                  <c:v>0.139064538391657</c:v>
                </c:pt>
                <c:pt idx="82">
                  <c:v>0.21672438106190001</c:v>
                </c:pt>
                <c:pt idx="83">
                  <c:v>0.25930422654546303</c:v>
                </c:pt>
                <c:pt idx="84">
                  <c:v>0.20689123687012001</c:v>
                </c:pt>
                <c:pt idx="85">
                  <c:v>0.13763678478819447</c:v>
                </c:pt>
                <c:pt idx="86">
                  <c:v>0.20689123687012001</c:v>
                </c:pt>
                <c:pt idx="87">
                  <c:v>0.15545866791995369</c:v>
                </c:pt>
                <c:pt idx="88">
                  <c:v>0.3158972678036065</c:v>
                </c:pt>
                <c:pt idx="89">
                  <c:v>0.29953027199120152</c:v>
                </c:pt>
                <c:pt idx="90">
                  <c:v>0.19099399551717638</c:v>
                </c:pt>
                <c:pt idx="91">
                  <c:v>0.22898324279678872</c:v>
                </c:pt>
                <c:pt idx="92">
                  <c:v>0.180582215521153</c:v>
                </c:pt>
                <c:pt idx="93">
                  <c:v>0.15465543963380524</c:v>
                </c:pt>
                <c:pt idx="94">
                  <c:v>0.29557430740719287</c:v>
                </c:pt>
                <c:pt idx="95">
                  <c:v>0.40884190819256</c:v>
                </c:pt>
                <c:pt idx="96">
                  <c:v>0.59600311126668237</c:v>
                </c:pt>
                <c:pt idx="97">
                  <c:v>0.47383898024497045</c:v>
                </c:pt>
                <c:pt idx="98">
                  <c:v>0.18490824399299172</c:v>
                </c:pt>
                <c:pt idx="99">
                  <c:v>0.55941572965099917</c:v>
                </c:pt>
                <c:pt idx="100">
                  <c:v>0.33921432839399501</c:v>
                </c:pt>
                <c:pt idx="101">
                  <c:v>0.6603924291877824</c:v>
                </c:pt>
                <c:pt idx="102">
                  <c:v>0.41034996829800002</c:v>
                </c:pt>
                <c:pt idx="103">
                  <c:v>0.32946859487498997</c:v>
                </c:pt>
                <c:pt idx="104">
                  <c:v>0.85338633063268998</c:v>
                </c:pt>
                <c:pt idx="105">
                  <c:v>0.49968261586550416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86772200"/>
        <c:axId val="186772584"/>
      </c:scatterChart>
      <c:valAx>
        <c:axId val="18677220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TI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772584"/>
        <c:crosses val="autoZero"/>
        <c:crossBetween val="midCat"/>
      </c:valAx>
      <c:valAx>
        <c:axId val="18677258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orm_Score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677220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53943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114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369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316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412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88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4286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2629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4859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339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0421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DE6F9-23CF-4175-96B6-64C3F89214D9}" type="datetimeFigureOut">
              <a:rPr lang="en-US" smtClean="0"/>
              <a:t>7/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00CAA5-F786-421C-8142-D597296AF4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230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0307601"/>
              </p:ext>
            </p:extLst>
          </p:nvPr>
        </p:nvGraphicFramePr>
        <p:xfrm>
          <a:off x="1403684" y="102268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3482217"/>
              </p:ext>
            </p:extLst>
          </p:nvPr>
        </p:nvGraphicFramePr>
        <p:xfrm>
          <a:off x="6745705" y="107081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15638382"/>
              </p:ext>
            </p:extLst>
          </p:nvPr>
        </p:nvGraphicFramePr>
        <p:xfrm>
          <a:off x="1387643" y="370973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65747" y="6328611"/>
            <a:ext cx="20893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3A, S3B, S3C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5455925" y="154806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A</a:t>
            </a:r>
            <a:endParaRPr lang="en-US" sz="12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10700084" y="1556084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B</a:t>
            </a:r>
            <a:endParaRPr lang="en-US" sz="12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467145" y="4267200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973474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24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Rong-Lin</dc:creator>
  <cp:lastModifiedBy>Wang, Rong-Lin</cp:lastModifiedBy>
  <cp:revision>6</cp:revision>
  <dcterms:created xsi:type="dcterms:W3CDTF">2015-04-23T12:53:02Z</dcterms:created>
  <dcterms:modified xsi:type="dcterms:W3CDTF">2015-07-09T15:53:57Z</dcterms:modified>
</cp:coreProperties>
</file>